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00" autoAdjust="0"/>
    <p:restoredTop sz="94660"/>
  </p:normalViewPr>
  <p:slideViewPr>
    <p:cSldViewPr snapToGrid="0">
      <p:cViewPr varScale="1">
        <p:scale>
          <a:sx n="74" d="100"/>
          <a:sy n="74" d="100"/>
        </p:scale>
        <p:origin x="57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0B743A-A333-48B2-AD4C-65AD0ED99064}" type="datetimeFigureOut">
              <a:rPr lang="en-US" smtClean="0"/>
              <a:t>7/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991B61-1F8E-4D75-8DD9-C2D3E17763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57850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0B743A-A333-48B2-AD4C-65AD0ED99064}" type="datetimeFigureOut">
              <a:rPr lang="en-US" smtClean="0"/>
              <a:t>7/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991B61-1F8E-4D75-8DD9-C2D3E17763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6427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0B743A-A333-48B2-AD4C-65AD0ED99064}" type="datetimeFigureOut">
              <a:rPr lang="en-US" smtClean="0"/>
              <a:t>7/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991B61-1F8E-4D75-8DD9-C2D3E17763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33113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0B743A-A333-48B2-AD4C-65AD0ED99064}" type="datetimeFigureOut">
              <a:rPr lang="en-US" smtClean="0"/>
              <a:t>7/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991B61-1F8E-4D75-8DD9-C2D3E17763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49795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0B743A-A333-48B2-AD4C-65AD0ED99064}" type="datetimeFigureOut">
              <a:rPr lang="en-US" smtClean="0"/>
              <a:t>7/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991B61-1F8E-4D75-8DD9-C2D3E17763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21987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0B743A-A333-48B2-AD4C-65AD0ED99064}" type="datetimeFigureOut">
              <a:rPr lang="en-US" smtClean="0"/>
              <a:t>7/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991B61-1F8E-4D75-8DD9-C2D3E17763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9900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0B743A-A333-48B2-AD4C-65AD0ED99064}" type="datetimeFigureOut">
              <a:rPr lang="en-US" smtClean="0"/>
              <a:t>7/4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991B61-1F8E-4D75-8DD9-C2D3E17763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92771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0B743A-A333-48B2-AD4C-65AD0ED99064}" type="datetimeFigureOut">
              <a:rPr lang="en-US" smtClean="0"/>
              <a:t>7/4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991B61-1F8E-4D75-8DD9-C2D3E17763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39987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0B743A-A333-48B2-AD4C-65AD0ED99064}" type="datetimeFigureOut">
              <a:rPr lang="en-US" smtClean="0"/>
              <a:t>7/4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991B61-1F8E-4D75-8DD9-C2D3E17763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67963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0B743A-A333-48B2-AD4C-65AD0ED99064}" type="datetimeFigureOut">
              <a:rPr lang="en-US" smtClean="0"/>
              <a:t>7/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991B61-1F8E-4D75-8DD9-C2D3E17763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55469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0B743A-A333-48B2-AD4C-65AD0ED99064}" type="datetimeFigureOut">
              <a:rPr lang="en-US" smtClean="0"/>
              <a:t>7/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991B61-1F8E-4D75-8DD9-C2D3E17763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16821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0B743A-A333-48B2-AD4C-65AD0ED99064}" type="datetimeFigureOut">
              <a:rPr lang="en-US" smtClean="0"/>
              <a:t>7/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991B61-1F8E-4D75-8DD9-C2D3E17763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4022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Espace réservé du contenu 4">
            <a:extLst>
              <a:ext uri="{FF2B5EF4-FFF2-40B4-BE49-F238E27FC236}">
                <a16:creationId xmlns:a16="http://schemas.microsoft.com/office/drawing/2014/main" xmlns="" id="{A8EAACD5-3731-3E41-BDE8-728F8EEE3C23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2697322" y="1428977"/>
            <a:ext cx="6797356" cy="4351338"/>
          </a:xfr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xmlns="" id="{F805CC13-8790-AB42-91DE-55689F6F5DCE}"/>
              </a:ext>
            </a:extLst>
          </p:cNvPr>
          <p:cNvSpPr/>
          <p:nvPr/>
        </p:nvSpPr>
        <p:spPr>
          <a:xfrm>
            <a:off x="456232" y="628456"/>
            <a:ext cx="174919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dirty="0" err="1">
                <a:latin typeface="Arial" panose="020B0604020202020204" pitchFamily="34" charset="0"/>
                <a:cs typeface="Arial" panose="020B0604020202020204" pitchFamily="34" charset="0"/>
              </a:rPr>
              <a:t>Additional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 file 4</a:t>
            </a:r>
            <a:endParaRPr lang="fr-FR" dirty="0"/>
          </a:p>
        </p:txBody>
      </p:sp>
      <p:sp>
        <p:nvSpPr>
          <p:cNvPr id="2" name="ZoneTexte 1">
            <a:extLst>
              <a:ext uri="{FF2B5EF4-FFF2-40B4-BE49-F238E27FC236}">
                <a16:creationId xmlns:a16="http://schemas.microsoft.com/office/drawing/2014/main" xmlns="" id="{97F6E023-F2BC-4249-B046-3C0D0C82EC66}"/>
              </a:ext>
            </a:extLst>
          </p:cNvPr>
          <p:cNvSpPr txBox="1"/>
          <p:nvPr/>
        </p:nvSpPr>
        <p:spPr>
          <a:xfrm>
            <a:off x="877246" y="5952817"/>
            <a:ext cx="1063742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Additional file 4</a:t>
            </a:r>
            <a:r>
              <a:rPr lang="en-US" sz="1400" dirty="0"/>
              <a:t>. Mottling score effect on post-tracheal intubation hypotension according to vasopressor use before tracheal intubation </a:t>
            </a:r>
            <a:endParaRPr lang="fr-FR" sz="1400" dirty="0"/>
          </a:p>
          <a:p>
            <a:endParaRPr lang="fr-FR" sz="1400" dirty="0"/>
          </a:p>
        </p:txBody>
      </p:sp>
    </p:spTree>
    <p:extLst>
      <p:ext uri="{BB962C8B-B14F-4D97-AF65-F5344CB8AC3E}">
        <p14:creationId xmlns:p14="http://schemas.microsoft.com/office/powerpoint/2010/main" val="21730937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1</Words>
  <Application>Microsoft Office PowerPoint</Application>
  <PresentationFormat>Widescreen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ranya M.</dc:creator>
  <cp:lastModifiedBy>Saranya M.</cp:lastModifiedBy>
  <cp:revision>1</cp:revision>
  <dcterms:created xsi:type="dcterms:W3CDTF">2022-07-04T08:57:27Z</dcterms:created>
  <dcterms:modified xsi:type="dcterms:W3CDTF">2022-07-04T08:57:34Z</dcterms:modified>
</cp:coreProperties>
</file>